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C64D902-B8DE-48A0-B1A8-8A2A60E59BFF}" v="3" dt="2023-07-30T01:16:10.58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42" d="100"/>
          <a:sy n="42" d="100"/>
        </p:scale>
        <p:origin x="228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RIYA RANI" userId="168e54ad-9b2c-4b18-be83-178c2e373f06" providerId="ADAL" clId="{8C64D902-B8DE-48A0-B1A8-8A2A60E59BFF}"/>
    <pc:docChg chg="addSld delSld modSld">
      <pc:chgData name="PRIYA RANI" userId="168e54ad-9b2c-4b18-be83-178c2e373f06" providerId="ADAL" clId="{8C64D902-B8DE-48A0-B1A8-8A2A60E59BFF}" dt="2023-07-30T01:16:10.584" v="2" actId="47"/>
      <pc:docMkLst>
        <pc:docMk/>
      </pc:docMkLst>
      <pc:sldChg chg="new del">
        <pc:chgData name="PRIYA RANI" userId="168e54ad-9b2c-4b18-be83-178c2e373f06" providerId="ADAL" clId="{8C64D902-B8DE-48A0-B1A8-8A2A60E59BFF}" dt="2023-07-30T01:16:10.584" v="2" actId="47"/>
        <pc:sldMkLst>
          <pc:docMk/>
          <pc:sldMk cId="3934408853" sldId="256"/>
        </pc:sldMkLst>
      </pc:sldChg>
      <pc:sldChg chg="add">
        <pc:chgData name="PRIYA RANI" userId="168e54ad-9b2c-4b18-be83-178c2e373f06" providerId="ADAL" clId="{8C64D902-B8DE-48A0-B1A8-8A2A60E59BFF}" dt="2023-07-30T01:16:08.540" v="1"/>
        <pc:sldMkLst>
          <pc:docMk/>
          <pc:sldMk cId="1698017149" sldId="25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797234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197455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8541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61950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254056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7131029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4553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96069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07523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76178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886068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B9047F-6A80-457E-85DB-EEBA6C829970}" type="datetimeFigureOut">
              <a:rPr lang="en-IN" smtClean="0"/>
              <a:t>30-07-20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6B1D5-C57C-48B1-88ED-138B9D1AD91B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6353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F6425D5-6129-13F9-4A02-6970D14DE5F8}"/>
              </a:ext>
            </a:extLst>
          </p:cNvPr>
          <p:cNvGraphicFramePr>
            <a:graphicFrameLocks noGrp="1"/>
          </p:cNvGraphicFramePr>
          <p:nvPr/>
        </p:nvGraphicFramePr>
        <p:xfrm>
          <a:off x="1508125" y="1421511"/>
          <a:ext cx="3841750" cy="4417886"/>
        </p:xfrm>
        <a:graphic>
          <a:graphicData uri="http://schemas.openxmlformats.org/drawingml/2006/table">
            <a:tbl>
              <a:tblPr bandRow="1"/>
              <a:tblGrid>
                <a:gridCol w="820268">
                  <a:extLst>
                    <a:ext uri="{9D8B030D-6E8A-4147-A177-3AD203B41FA5}">
                      <a16:colId xmlns:a16="http://schemas.microsoft.com/office/drawing/2014/main" val="3165700721"/>
                    </a:ext>
                  </a:extLst>
                </a:gridCol>
                <a:gridCol w="1743863">
                  <a:extLst>
                    <a:ext uri="{9D8B030D-6E8A-4147-A177-3AD203B41FA5}">
                      <a16:colId xmlns:a16="http://schemas.microsoft.com/office/drawing/2014/main" val="2070283322"/>
                    </a:ext>
                  </a:extLst>
                </a:gridCol>
                <a:gridCol w="1277619">
                  <a:extLst>
                    <a:ext uri="{9D8B030D-6E8A-4147-A177-3AD203B41FA5}">
                      <a16:colId xmlns:a16="http://schemas.microsoft.com/office/drawing/2014/main" val="3870671567"/>
                    </a:ext>
                  </a:extLst>
                </a:gridCol>
              </a:tblGrid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. No.</a:t>
                      </a:r>
                      <a:endParaRPr lang="en-IN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i="1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miRNA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b="1" i="1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inding site</a:t>
                      </a:r>
                      <a:endParaRPr lang="en-IN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2107946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212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VI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2087536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184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/w IV and 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2633045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127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3283626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330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232920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520g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</a:t>
                      </a:r>
                      <a:r>
                        <a:rPr lang="en-IN" sz="1200" kern="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V</a:t>
                      </a:r>
                      <a:endParaRPr lang="en-IN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1329916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22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/w sl V and VI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0678667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520h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6499719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134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I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0510904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213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I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90929858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324-3p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I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4086001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372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I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91144046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453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I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0444944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491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IN" sz="1200" kern="1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l IV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0326838"/>
                  </a:ext>
                </a:extLst>
              </a:tr>
              <a:tr h="288290"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sa-miR-539</a:t>
                      </a:r>
                      <a:endParaRPr lang="en-IN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228600"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200" kern="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’UTR</a:t>
                      </a:r>
                      <a:endParaRPr lang="en-IN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7011259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D8CFDD27-FAEB-DD26-52EF-7401A6F62706}"/>
              </a:ext>
            </a:extLst>
          </p:cNvPr>
          <p:cNvSpPr txBox="1"/>
          <p:nvPr/>
        </p:nvSpPr>
        <p:spPr>
          <a:xfrm>
            <a:off x="525780" y="793047"/>
            <a:ext cx="9121140" cy="4090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28600" algn="just">
              <a:lnSpc>
                <a:spcPct val="200000"/>
              </a:lnSpc>
              <a:spcAft>
                <a:spcPts val="800"/>
              </a:spcAft>
            </a:pPr>
            <a:r>
              <a:rPr lang="en-IN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ble S1. 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ist of miRNAs with high probability of binding to CVB3 UTRs</a:t>
            </a:r>
            <a:endParaRPr lang="en-IN" sz="11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80171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85</Words>
  <Application>Microsoft Office PowerPoint</Application>
  <PresentationFormat>A4 Paper (210x297 mm)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IYA RANI</dc:creator>
  <cp:lastModifiedBy>PRIYA RANI</cp:lastModifiedBy>
  <cp:revision>1</cp:revision>
  <dcterms:created xsi:type="dcterms:W3CDTF">2023-07-30T01:15:38Z</dcterms:created>
  <dcterms:modified xsi:type="dcterms:W3CDTF">2023-07-30T01:16:13Z</dcterms:modified>
</cp:coreProperties>
</file>